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5"/>
  </p:notesMasterIdLst>
  <p:handoutMasterIdLst>
    <p:handoutMasterId r:id="rId6"/>
  </p:handoutMasterIdLst>
  <p:sldIdLst>
    <p:sldId id="269" r:id="rId2"/>
    <p:sldId id="270" r:id="rId3"/>
    <p:sldId id="271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030">
          <p15:clr>
            <a:srgbClr val="A4A3A4"/>
          </p15:clr>
        </p15:guide>
        <p15:guide id="2" orient="horz" pos="3975">
          <p15:clr>
            <a:srgbClr val="A4A3A4"/>
          </p15:clr>
        </p15:guide>
        <p15:guide id="3" orient="horz" pos="935">
          <p15:clr>
            <a:srgbClr val="A4A3A4"/>
          </p15:clr>
        </p15:guide>
        <p15:guide id="4" orient="horz" pos="390">
          <p15:clr>
            <a:srgbClr val="A4A3A4"/>
          </p15:clr>
        </p15:guide>
        <p15:guide id="5" pos="368">
          <p15:clr>
            <a:srgbClr val="A4A3A4"/>
          </p15:clr>
        </p15:guide>
        <p15:guide id="6" pos="5391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2" autoAdjust="0"/>
    <p:restoredTop sz="94630" autoAdjust="0"/>
  </p:normalViewPr>
  <p:slideViewPr>
    <p:cSldViewPr snapToGrid="0" snapToObjects="1" showGuides="1">
      <p:cViewPr varScale="1">
        <p:scale>
          <a:sx n="95" d="100"/>
          <a:sy n="95" d="100"/>
        </p:scale>
        <p:origin x="-3006" y="-96"/>
      </p:cViewPr>
      <p:guideLst>
        <p:guide orient="horz" pos="1373"/>
        <p:guide orient="horz" pos="5300"/>
        <p:guide orient="horz" pos="1247"/>
        <p:guide orient="horz" pos="520"/>
        <p:guide pos="276"/>
        <p:guide pos="404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12/12/2016</a:t>
            </a:fld>
            <a:endParaRPr lang="en-GB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12/12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4004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3977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77924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7.png"/><Relationship Id="rId7" Type="http://schemas.openxmlformats.org/officeDocument/2006/relationships/image" Target="../media/image20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5F63992-81DD-4E59-90FA-74361159722F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40532" y="2180167"/>
            <a:ext cx="5975747" cy="6223000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2F889-A811-4C65-BC10-FC6818A20D47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right and imag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AFF43-DB95-4864-B236-B0B6E8F4F2A0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 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9B226-DDC5-405C-8EA3-5453C1E8EB5D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righ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3E65C-360B-4039-AB89-06F19BC315AD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tabLst/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4932000" tIns="360000" rIns="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A19FB-3072-4077-AA42-D28791A679DA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apital bullet lis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BC56-A7A8-4003-BEB7-E47F01DF87DF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829735"/>
            <a:ext cx="5975747" cy="7574669"/>
          </a:xfrm>
          <a:noFill/>
        </p:spPr>
        <p:txBody>
          <a:bodyPr lIns="0" tIns="0" rIns="0" bIns="0"/>
          <a:lstStyle>
            <a:lvl1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ation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342052" y="817179"/>
            <a:ext cx="656786" cy="18235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250" b="1" dirty="0">
                <a:solidFill>
                  <a:schemeClr val="bg1"/>
                </a:solidFill>
              </a:rPr>
              <a:t>”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6F94A-E0B8-4DFD-A908-EFEAB82AF80D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5975747" cy="5480049"/>
          </a:xfrm>
          <a:noFill/>
        </p:spPr>
        <p:txBody>
          <a:bodyPr lIns="0" tIns="0" rIns="0" bIns="0" anchor="t" anchorCtr="0"/>
          <a:lstStyle>
            <a:lvl1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2" y="7913295"/>
            <a:ext cx="5975747" cy="489872"/>
          </a:xfrm>
        </p:spPr>
        <p:txBody>
          <a:bodyPr>
            <a:normAutofit/>
          </a:bodyPr>
          <a:lstStyle>
            <a:lvl1pPr marL="0" indent="0">
              <a:buNone/>
              <a:defRPr sz="24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/>
              <a:t>Name, source</a:t>
            </a:r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mirrored texts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63E39-AF6B-40E3-8BF3-7E834A04E609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2901437" cy="6226352"/>
          </a:xfrm>
          <a:noFill/>
        </p:spPr>
        <p:txBody>
          <a:bodyPr lIns="0" tIns="0" rIns="0" bIns="0"/>
          <a:lstStyle>
            <a:lvl1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09070" y="2178051"/>
            <a:ext cx="2907209" cy="6226352"/>
          </a:xfrm>
          <a:noFill/>
        </p:spPr>
        <p:txBody>
          <a:bodyPr lIns="0" tIns="0" rIns="0" bIns="0"/>
          <a:lstStyle>
            <a:lvl1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7" name="Titel 1"/>
          <p:cNvSpPr>
            <a:spLocks noGrp="1"/>
          </p:cNvSpPr>
          <p:nvPr>
            <p:ph type="title"/>
          </p:nvPr>
        </p:nvSpPr>
        <p:spPr>
          <a:xfrm>
            <a:off x="440532" y="829734"/>
            <a:ext cx="5975747" cy="1132417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ing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EC2F4-462D-4BD4-9025-86FD7D8AF145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2178050"/>
            <a:ext cx="5975747" cy="6225116"/>
          </a:xfrm>
        </p:spPr>
        <p:txBody>
          <a:bodyPr anchor="t" anchorCtr="0"/>
          <a:lstStyle>
            <a:lvl1pPr>
              <a:defRPr sz="6400" b="0" baseline="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EC015-C244-4BA1-A831-6C8E63A96CC2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lang="da-DK" sz="24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4BAEE1E-B5FD-4740-ACDA-6CAFC8D24650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390273"/>
            <a:ext cx="26725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D4858-3149-45CE-A7BF-0594A400CFEA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1802765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User 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/>
          <p:cNvSpPr txBox="1">
            <a:spLocks/>
          </p:cNvSpPr>
          <p:nvPr userDrawn="1"/>
        </p:nvSpPr>
        <p:spPr>
          <a:xfrm>
            <a:off x="440532" y="825501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3000" dirty="0">
                <a:solidFill>
                  <a:schemeClr val="tx1"/>
                </a:solidFill>
              </a:rPr>
              <a:t>User guide </a:t>
            </a:r>
            <a:r>
              <a:rPr lang="en-GB" sz="1800" dirty="0">
                <a:solidFill>
                  <a:schemeClr val="tx1"/>
                </a:solidFill>
              </a:rPr>
              <a:t>– delete before use</a:t>
            </a:r>
          </a:p>
        </p:txBody>
      </p:sp>
      <p:sp>
        <p:nvSpPr>
          <p:cNvPr id="46" name="Text Box 48"/>
          <p:cNvSpPr txBox="1">
            <a:spLocks noChangeArrowheads="1"/>
          </p:cNvSpPr>
          <p:nvPr userDrawn="1"/>
        </p:nvSpPr>
        <p:spPr bwMode="auto">
          <a:xfrm>
            <a:off x="440532" y="2187327"/>
            <a:ext cx="1312718" cy="528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PowerPoint templates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open PowerPoint on your UCPH computer, </a:t>
            </a:r>
            <a:r>
              <a:rPr lang="en-GB" sz="800" kern="1200" dirty="0" smtClean="0">
                <a:solidFill>
                  <a:schemeClr val="tx1"/>
                </a:solidFill>
                <a:effectLst/>
                <a:latin typeface="Arial" charset="0"/>
                <a:ea typeface="Calibri" panose="020F0502020204030204" pitchFamily="34" charset="0"/>
                <a:cs typeface="Times New Roman" panose="02020603050405020304" pitchFamily="18" charset="0"/>
              </a:rPr>
              <a:t>PowerPoint open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a template in 4:3 format with an English UCPH logo.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click on the UCPH tab in the toolbar, click "Select Template" to choose between template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Danish and English 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4:3 and 16:9 format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"full" or "empty" versions (in the full version there is an example of each slide type in the left-hand window)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s well as an example slide with text in English.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f you use a 'full' version, you must delete the slides you do not want to use.</a:t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 users and others can download PowerPoint templates at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skabeloner/powerpoint/praesentationer/</a:t>
            </a:r>
            <a:endParaRPr lang="en-GB" sz="80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7" name="Text Box 48"/>
          <p:cNvSpPr txBox="1">
            <a:spLocks noChangeArrowheads="1"/>
          </p:cNvSpPr>
          <p:nvPr userDrawn="1"/>
        </p:nvSpPr>
        <p:spPr bwMode="auto">
          <a:xfrm>
            <a:off x="1927788" y="5288303"/>
            <a:ext cx="1316661" cy="252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your unit name (e.g. your department), page numbers and the date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lick on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n the top menu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ader and Footer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ll in the fields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 all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f it is only to be used on a single slide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he information goes on the right-hand side of the page in the grey top bar.</a:t>
            </a:r>
            <a:endParaRPr lang="en-GB" sz="8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440531" y="7585174"/>
            <a:ext cx="142469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reate a new slide (2010 + 2013 and 2016 version) 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  <a:endParaRPr lang="en-GB" altLang="da-DK" sz="80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49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3118228" y="3862209"/>
            <a:ext cx="296562" cy="168836"/>
          </a:xfrm>
          <a:prstGeom prst="rect">
            <a:avLst/>
          </a:prstGeom>
        </p:spPr>
      </p:pic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1927788" y="3443103"/>
            <a:ext cx="1218181" cy="877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Replace slide type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elect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to change the layout of your current slide.</a:t>
            </a:r>
            <a:endParaRPr lang="en-GB" altLang="da-DK" sz="80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1" name="Text Box 48"/>
          <p:cNvSpPr txBox="1">
            <a:spLocks noChangeArrowheads="1"/>
          </p:cNvSpPr>
          <p:nvPr userDrawn="1"/>
        </p:nvSpPr>
        <p:spPr bwMode="auto">
          <a:xfrm>
            <a:off x="1927788" y="4420123"/>
            <a:ext cx="1225968" cy="5334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Font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uses the font Microsoft New Tai Lue in PowerPoint.</a:t>
            </a:r>
            <a:endParaRPr lang="en-GB" altLang="da-DK" sz="80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3554336" y="2169500"/>
            <a:ext cx="1225968" cy="28438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s and Guid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see gridlines and guides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lick on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ew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and/or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establish additional gridlines and 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ver the mouse over an existing gridline and click on the line (coordinates of the line are displayed)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down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 key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while you move the location of the line (adds a new line)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ress Alt + F9 for a rapid display of gridlines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3546616" y="5521890"/>
            <a:ext cx="1225968" cy="24745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picture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On layouts with picture placeholders: Click the icon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text  ”Clik here to insert image” will not be visible in presentation mode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find UCPH-images, which are adapted to and minimised to the 4:3 and 16:9 format via this link: </a:t>
            </a:r>
            <a:b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80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80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slide show-view to activate the link.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5018671" y="2187327"/>
            <a:ext cx="1225968" cy="1366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mage siz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optimal picture sizes ar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ave the images in 72 dpi and in "jpg medium quality"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5018671" y="3626675"/>
            <a:ext cx="1225968" cy="2613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imming pictur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Click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Crop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change the image focus/siz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want to scale the picture, hold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button down while dragging in the image corner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picture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delete the picture and inserts a new, the picture may be in front of text and graphics. If this happens, you must select the image, right-click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  <a:endParaRPr lang="en-GB" sz="80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5018671" y="6353763"/>
            <a:ext cx="1225968" cy="1212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mplate color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choose between a range of colors for backgrounds and graphs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surface of which you want to change the color and then click on the paint can icon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5018671" y="7753517"/>
            <a:ext cx="1225968" cy="941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urther information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e</a:t>
            </a:r>
            <a: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b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www.designguide.ku.dk/ku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skabeloner/powerpoint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praesentationer/</a:t>
            </a:r>
            <a:endParaRPr lang="en-GB" sz="80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58" name="Billede 25"/>
          <p:cNvPicPr>
            <a:picLocks noChangeAspect="1"/>
          </p:cNvPicPr>
          <p:nvPr userDrawn="1"/>
        </p:nvPicPr>
        <p:blipFill>
          <a:blip r:embed="rId5"/>
          <a:stretch>
            <a:fillRect/>
          </a:stretch>
        </p:blipFill>
        <p:spPr>
          <a:xfrm>
            <a:off x="4701034" y="5601883"/>
            <a:ext cx="192995" cy="367040"/>
          </a:xfrm>
          <a:prstGeom prst="rect">
            <a:avLst/>
          </a:prstGeom>
        </p:spPr>
      </p:pic>
      <p:pic>
        <p:nvPicPr>
          <p:cNvPr id="59" name="Billede 36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6167654" y="3727171"/>
            <a:ext cx="216531" cy="367040"/>
          </a:xfrm>
          <a:prstGeom prst="rect">
            <a:avLst/>
          </a:prstGeom>
        </p:spPr>
      </p:pic>
      <p:pic>
        <p:nvPicPr>
          <p:cNvPr id="60" name="Billede 37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6181369" y="4250386"/>
            <a:ext cx="167342" cy="305124"/>
          </a:xfrm>
          <a:prstGeom prst="rect">
            <a:avLst/>
          </a:prstGeom>
        </p:spPr>
      </p:pic>
      <p:sp>
        <p:nvSpPr>
          <p:cNvPr id="61" name="Text Box 48"/>
          <p:cNvSpPr txBox="1">
            <a:spLocks noChangeArrowheads="1"/>
          </p:cNvSpPr>
          <p:nvPr userDrawn="1"/>
        </p:nvSpPr>
        <p:spPr bwMode="auto">
          <a:xfrm>
            <a:off x="1927788" y="2221504"/>
            <a:ext cx="1326102" cy="9848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the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ew slide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button Click on the top part of the button to create a slide identical to the one selected. Click on the bottom part of the button to see a selection of possible layout choices</a:t>
            </a:r>
            <a:endParaRPr lang="en-GB" altLang="da-DK" sz="80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2" name="Picture 21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3203909" y="2324983"/>
            <a:ext cx="182390" cy="577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/>
            </a:r>
            <a:br>
              <a:rPr lang="en-GB" dirty="0"/>
            </a:br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  <a:p>
            <a:r>
              <a:rPr lang="en-GB" dirty="0"/>
              <a:t> 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2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5EC0A1D8-3ABB-4543-BDE4-494CA30745CE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1811" y="5404800"/>
            <a:ext cx="26244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91811" y="4009715"/>
            <a:ext cx="2624468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aseline="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1811" y="1360267"/>
            <a:ext cx="2633993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228DFFFC-8FEB-49C6-9D0D-E0BD92A86F5F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0801" y="5404800"/>
            <a:ext cx="262547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0801" y="3481255"/>
            <a:ext cx="2635003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la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FA633E42-BD66-4E16-AB4B-D4F73B67BBBB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sma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0A47663-4FC2-4F88-9BD5-092FD898EE9B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2569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1" y="825500"/>
            <a:ext cx="5975748" cy="1153584"/>
          </a:xfrm>
        </p:spPr>
        <p:txBody>
          <a:bodyPr/>
          <a:lstStyle>
            <a:lvl1pPr>
              <a:defRPr baseline="0"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440532" y="2180167"/>
            <a:ext cx="5975747" cy="6224237"/>
          </a:xfrm>
        </p:spPr>
        <p:txBody>
          <a:bodyPr vert="horz" lIns="0" tIns="0" rIns="0" bIns="0" rtlCol="0">
            <a:noAutofit/>
          </a:bodyPr>
          <a:lstStyle>
            <a:lvl1pPr>
              <a:defRPr lang="da-DK" baseline="0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3CBA-FE51-40BA-9B41-89C7FDAF5BF4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wo content objec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3" y="2178052"/>
            <a:ext cx="2904935" cy="6225115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09069" y="2180167"/>
            <a:ext cx="2907210" cy="6223000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4B769-5527-4DD4-9DA1-DF6DC20FE7C2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,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dsholder til billede 9"/>
          <p:cNvSpPr>
            <a:spLocks noGrp="1"/>
          </p:cNvSpPr>
          <p:nvPr>
            <p:ph type="pic" sz="quarter" idx="15" hasCustomPrompt="1"/>
          </p:nvPr>
        </p:nvSpPr>
        <p:spPr>
          <a:xfrm>
            <a:off x="3512047" y="2180168"/>
            <a:ext cx="2904232" cy="6223001"/>
          </a:xfrm>
          <a:blipFill>
            <a:blip r:embed="rId2"/>
            <a:srcRect/>
            <a:stretch>
              <a:fillRect l="-11" r="-9936"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>
            <a:lvl1pPr>
              <a:defRPr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2" y="2180168"/>
            <a:ext cx="2911865" cy="6223001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1E670-9FB7-4315-84DE-52FB48770D82}" type="datetime1">
              <a:rPr lang="en-GB" smtClean="0"/>
              <a:t>12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40532" y="825500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40532" y="2180167"/>
            <a:ext cx="5975747" cy="6224237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  <a:p>
            <a:pPr lvl="1"/>
            <a:r>
              <a:rPr lang="da-DK" dirty="0"/>
              <a:t>2</a:t>
            </a:r>
          </a:p>
          <a:p>
            <a:pPr lvl="2"/>
            <a:r>
              <a:rPr lang="da-DK" dirty="0"/>
              <a:t>3</a:t>
            </a:r>
          </a:p>
          <a:p>
            <a:pPr lvl="3"/>
            <a:r>
              <a:rPr lang="da-DK" dirty="0"/>
              <a:t>4</a:t>
            </a:r>
          </a:p>
          <a:p>
            <a:pPr lvl="4"/>
            <a:r>
              <a:rPr lang="da-DK" dirty="0"/>
              <a:t>5</a:t>
            </a:r>
          </a:p>
          <a:p>
            <a:pPr lvl="5"/>
            <a:r>
              <a:rPr lang="da-DK" dirty="0"/>
              <a:t>6</a:t>
            </a:r>
          </a:p>
          <a:p>
            <a:pPr lvl="6"/>
            <a:r>
              <a:rPr lang="da-DK" dirty="0"/>
              <a:t>7</a:t>
            </a:r>
          </a:p>
          <a:p>
            <a:pPr lvl="7"/>
            <a:r>
              <a:rPr lang="da-DK" dirty="0"/>
              <a:t>8</a:t>
            </a:r>
          </a:p>
          <a:p>
            <a:pPr lvl="8"/>
            <a:r>
              <a:rPr lang="da-DK" dirty="0"/>
              <a:t>9</a:t>
            </a:r>
          </a:p>
          <a:p>
            <a:pPr lvl="4"/>
            <a:endParaRPr lang="da-DK" dirty="0"/>
          </a:p>
          <a:p>
            <a:pPr marL="402431" marR="0" lvl="1" indent="-198835" algn="l" defTabSz="685800" rtl="0" eaLnBrk="1" fontAlgn="auto" latinLnBrk="0" hangingPunct="1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da-DK" dirty="0"/>
          </a:p>
        </p:txBody>
      </p:sp>
      <p:sp>
        <p:nvSpPr>
          <p:cNvPr id="7" name="Rectangle 19"/>
          <p:cNvSpPr/>
          <p:nvPr/>
        </p:nvSpPr>
        <p:spPr>
          <a:xfrm>
            <a:off x="0" y="5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238418" y="114329"/>
            <a:ext cx="3126128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133436" y="114329"/>
            <a:ext cx="282843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da-DK" smtClean="0"/>
              <a:pPr/>
              <a:t>‹#›</a:t>
            </a:fld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454542" y="114329"/>
            <a:ext cx="611232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78B939E7-E8BE-4EDC-A4C7-4CF4D90B066E}" type="datetime1">
              <a:rPr lang="da-DK" smtClean="0"/>
              <a:t>12-12-2016</a:t>
            </a:fld>
            <a:endParaRPr lang="da-DK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4"/>
          <a:srcRect l="12043" t="11448" r="17199" b="13844"/>
          <a:stretch/>
        </p:blipFill>
        <p:spPr>
          <a:xfrm>
            <a:off x="251651" y="84771"/>
            <a:ext cx="124887" cy="281728"/>
          </a:xfrm>
          <a:prstGeom prst="rect">
            <a:avLst/>
          </a:prstGeom>
        </p:spPr>
      </p:pic>
      <p:pic>
        <p:nvPicPr>
          <p:cNvPr id="15" name="Picture 2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71" y="128623"/>
            <a:ext cx="1749486" cy="212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685800" rtl="0" eaLnBrk="1" latinLnBrk="0" hangingPunct="1">
        <a:lnSpc>
          <a:spcPct val="100000"/>
        </a:lnSpc>
        <a:spcBef>
          <a:spcPct val="0"/>
        </a:spcBef>
        <a:buNone/>
        <a:defRPr sz="3000" kern="1200" spc="45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71463" indent="-271463" algn="l" defTabSz="685800" rtl="0" eaLnBrk="1" latinLnBrk="0" hangingPunct="1">
        <a:lnSpc>
          <a:spcPct val="100000"/>
        </a:lnSpc>
        <a:spcBef>
          <a:spcPts val="750"/>
        </a:spcBef>
        <a:buFont typeface="Arial" panose="020B0604020202020204" pitchFamily="34" charset="0"/>
        <a:buChar char="•"/>
        <a:defRPr sz="2400" kern="1200" spc="45" baseline="0">
          <a:solidFill>
            <a:schemeClr val="tx1"/>
          </a:solidFill>
          <a:latin typeface="+mn-lt"/>
          <a:ea typeface="+mn-ea"/>
          <a:cs typeface="+mn-cs"/>
        </a:defRPr>
      </a:lvl1pPr>
      <a:lvl2pPr marL="535781" marR="0" indent="-264319" algn="l" defTabSz="685800" rtl="0" eaLnBrk="1" fontAlgn="auto" latinLnBrk="0" hangingPunct="1">
        <a:lnSpc>
          <a:spcPct val="100000"/>
        </a:lnSpc>
        <a:spcBef>
          <a:spcPts val="375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2000" kern="1200" spc="45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808038" indent="-271463" algn="l" defTabSz="685800" rtl="0" eaLnBrk="1" latinLnBrk="0" hangingPunct="1">
        <a:lnSpc>
          <a:spcPct val="100000"/>
        </a:lnSpc>
        <a:spcBef>
          <a:spcPts val="375"/>
        </a:spcBef>
        <a:buFont typeface="Arial" panose="020B0604020202020204" pitchFamily="34" charset="0"/>
        <a:buChar char="•"/>
        <a:defRPr sz="1600" kern="1200" spc="45" baseline="0">
          <a:solidFill>
            <a:schemeClr val="tx1"/>
          </a:solidFill>
          <a:latin typeface="+mn-lt"/>
          <a:ea typeface="+mn-ea"/>
          <a:cs typeface="+mn-cs"/>
        </a:defRPr>
      </a:lvl5pPr>
      <a:lvl6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="" xmlns:p15="http://schemas.microsoft.com/office/powerpoint/2012/main">
        <p15:guide id="1" pos="370" userDrawn="1">
          <p15:clr>
            <a:srgbClr val="F26B43"/>
          </p15:clr>
        </p15:guide>
        <p15:guide id="2" pos="5389" userDrawn="1">
          <p15:clr>
            <a:srgbClr val="F26B43"/>
          </p15:clr>
        </p15:guide>
        <p15:guide id="3" orient="horz" pos="1029" userDrawn="1">
          <p15:clr>
            <a:srgbClr val="F26B43"/>
          </p15:clr>
        </p15:guide>
        <p15:guide id="4" orient="horz" pos="3970" userDrawn="1">
          <p15:clr>
            <a:srgbClr val="F26B43"/>
          </p15:clr>
        </p15:guide>
        <p15:guide id="5" pos="5397" userDrawn="1">
          <p15:clr>
            <a:srgbClr val="F26B43"/>
          </p15:clr>
        </p15:guide>
        <p15:guide id="6" orient="horz" pos="392" userDrawn="1">
          <p15:clr>
            <a:srgbClr val="F26B43"/>
          </p15:clr>
        </p15:guide>
        <p15:guide id="7" orient="horz" pos="92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4066" y="729358"/>
            <a:ext cx="6342062" cy="82073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62705" y="160780"/>
            <a:ext cx="56572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latin typeface="Times New Roman"/>
                <a:ea typeface="Calibri"/>
                <a:cs typeface="Times New Roman"/>
              </a:rPr>
              <a:t>Additional file 5. </a:t>
            </a:r>
            <a:r>
              <a:rPr lang="en-US" sz="1200" b="1" dirty="0" err="1">
                <a:latin typeface="Times New Roman"/>
                <a:ea typeface="Calibri"/>
                <a:cs typeface="Times New Roman"/>
              </a:rPr>
              <a:t>Dendrograms</a:t>
            </a:r>
            <a:r>
              <a:rPr lang="en-US" sz="1200" b="1" dirty="0">
                <a:latin typeface="Times New Roman"/>
                <a:ea typeface="Calibri"/>
                <a:cs typeface="Times New Roman"/>
              </a:rPr>
              <a:t> showing the relatedness of </a:t>
            </a:r>
            <a:r>
              <a:rPr lang="en-US" sz="1200" b="1" i="1" dirty="0">
                <a:latin typeface="Times New Roman"/>
                <a:ea typeface="Calibri"/>
                <a:cs typeface="Times New Roman"/>
              </a:rPr>
              <a:t>E. coli</a:t>
            </a:r>
            <a:r>
              <a:rPr lang="en-US" sz="1200" b="1" dirty="0">
                <a:latin typeface="Times New Roman"/>
                <a:ea typeface="Calibri"/>
                <a:cs typeface="Times New Roman"/>
              </a:rPr>
              <a:t> strains within each group of strains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(isolated from media with or without antibiotic)</a:t>
            </a:r>
            <a:endParaRPr lang="da-DK" sz="1200" dirty="0">
              <a:effectLst/>
              <a:latin typeface="Calibri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50181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483" y="392676"/>
            <a:ext cx="6672105" cy="86344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614231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190919"/>
            <a:ext cx="6879455" cy="89028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032672382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4_3_ENG_small.potx" id="{7372F832-0FEC-4AE6-91CC-93C5EF5800A9}" vid="{D093ABB3-BDDF-4E0E-96BC-BAAD417507A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30</Words>
  <Application>Microsoft Office PowerPoint</Application>
  <PresentationFormat>On-screen Show (4:3)</PresentationFormat>
  <Paragraphs>4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blank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6-09-14T10:42:09Z</dcterms:created>
  <dcterms:modified xsi:type="dcterms:W3CDTF">2016-12-12T10:34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</Properties>
</file>